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850" y="-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69B68D-1F43-1C3E-6BCA-B2880124FE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7D1441-10C5-DFC1-2279-3B488220D8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03CA29-EA3C-02EA-53DE-D4DA9D814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A8ED7-70F7-2F3C-A3EA-95C9F705F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79C8D-33B1-B4DC-6E4B-35FCA65D1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6129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2AD35D-61B3-3B48-5541-36A78C2F1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E5718A-5106-DF99-DD0D-06D0A3515B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AC90E8-5979-43CD-7829-C78D86029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B4E72D-D820-0DAA-57F5-EE97199C2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299113-2C6C-8996-8888-F26227047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56834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6506AFC-D525-925E-E3E9-A401FBF95A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AC42E1-BBEE-2883-8169-CCEFE173E6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6DC244-68FA-C6FC-CE63-DE4FDA7CD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DBDD77-A2C2-41E3-7C6D-709D0A7DB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EE8C2B-3E2F-79F4-2794-0CCEF4853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6062728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151722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CC2AA5-397A-8562-E13B-56D0EE5326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CCC1AA-71E0-8058-2817-9A0F102868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C0E1DB-3E18-9D24-1807-9B4B5C806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9F9C71-B1E5-68B7-7A84-4C3C4E78C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84B460-583D-A5E6-3241-3298AAC10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73133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2844C1-28C6-5ECB-2B32-3B6713D92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2C910C-7102-9505-38B9-B1140E0054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E379E-9907-370B-E5A1-7DEB54B64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E06FCE-55D0-488A-C794-5A53C00CA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AAD9E4-838E-85D4-A3B3-4A03549F3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94388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CF73B3-88CD-C6D5-B648-2F8011BCE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2AB627-6811-67D7-2DF6-9097B4CE64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C0D4AF-1840-4332-51B9-5FA4CE6602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27E482-28EC-16CD-B36C-137144F6B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373F41-BD79-F6BC-0DED-F828C94AE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1A8516-9DD8-D8D5-4520-2BC49441F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7611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61C858-0AD7-75D1-8F39-82EA0EBFF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9B8832-FF12-48DC-1E74-78C285C67A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85B114-F2BF-32AF-4154-EF7B50C572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106760-9032-B836-E8D2-B6D24DEE98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4CA6C8C-1095-17E1-85DD-26F464786A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913D12-5DFB-7CD7-56D6-CA85EEA0B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FBFF7B-A22A-CBA5-1CC4-DD2720522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C134E4B-0786-0139-5FEC-8A5209221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73499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A90952-F78E-AA1A-2DDC-3D43BB977C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217749-E30C-BC94-7E66-D99A2799B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FB30BC-55B9-EBEF-DA10-584A97C53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0CD888-C2B7-3477-31A2-AB79489A5B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93343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16476C9-25A8-6932-9AE1-3047184DC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0FC5E0-6A58-36CB-7031-AC50BCB04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32E8BF-8972-5A85-FDA3-0836F9EE4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8965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8C8A9E-9F89-D0E1-E2D0-617BADFD5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16ACBF-E9AE-7178-222A-AE24FCF482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ED9175-A2A8-9D79-1042-C11DD03825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F5F21F-2DF0-3C7E-50AC-881573617C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BE9794-413D-8D1D-61C5-8E3CF1EFD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52C867-5AA7-D68F-43D9-5A9E7BF8C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87607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307E58-5F1C-0DA5-E6DE-2CDCB6E302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09A8B9-C38F-ED39-342B-D17C564311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05820A-A594-76EA-AE07-5EFDCD60EC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19BD2B-A527-34BC-9C67-3B3BAE55F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16F559-972E-ECE5-6AA6-860221D151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95B591-BD09-0006-413D-8CBC62EF9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19311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358667-FB77-2ACC-27DF-261EF4DC87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D21427-76B6-EFA5-26C7-82BA3BE494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0FE787-013D-3804-33CC-241DB79415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FFC510-2396-46F4-899B-2C0F5A65C424}" type="datetimeFigureOut">
              <a:rPr lang="de-CH" smtClean="0"/>
              <a:t>16.05.2025</a:t>
            </a:fld>
            <a:endParaRPr lang="de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B65D5-D7DA-530A-CDFA-F48F73CA66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3ED326-5419-735B-CE47-8C0C30DE63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EF924E-4387-4D6D-BB55-F5BD6014B23A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81541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  <a:spcAft>
                <a:spcPts val="800"/>
              </a:spcAft>
            </a:pPr>
            <a:r>
              <a:rPr lang="en-US" sz="28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imary renal diffuse large B-cell lymphoma </a:t>
            </a:r>
          </a:p>
          <a:p>
            <a:pPr>
              <a:lnSpc>
                <a:spcPct val="100000"/>
              </a:lnSpc>
              <a:spcAft>
                <a:spcPts val="800"/>
              </a:spcAft>
            </a:pPr>
            <a:r>
              <a:rPr lang="en-US" sz="2800" b="1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esenting as new-onset kidney failure </a:t>
            </a:r>
            <a:endParaRPr lang="de-CH" sz="28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80865" y="1039663"/>
            <a:ext cx="1008789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IM</a:t>
            </a:r>
            <a:r>
              <a:rPr lang="en-GB" sz="17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US" sz="17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sz="17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 practical approach to optimize chemotherapy on kidney replacement therapy in a rare case of primary bilateral renal diffuse large B-cell lymphoma presenting with kidney failure. </a:t>
            </a:r>
            <a:endParaRPr lang="en-GB" sz="1700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09649" y="1726536"/>
            <a:ext cx="7238449" cy="42945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lvl="0" indent="-342900">
              <a:lnSpc>
                <a:spcPct val="115000"/>
              </a:lnSpc>
              <a:buFont typeface="Aptos" panose="020B0004020202020204" pitchFamily="34" charset="0"/>
              <a:buChar char="-"/>
            </a:pPr>
            <a:r>
              <a:rPr lang="en-US" sz="1800" kern="1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 biopsy-first approach is preferred over nephrectomy due to the potential for kidney function recovery. </a:t>
            </a:r>
            <a:endParaRPr lang="de-CH" sz="1800" kern="100" dirty="0">
              <a:solidFill>
                <a:schemeClr val="tx2"/>
              </a:solidFill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  <a:p>
            <a:pPr marL="342900" lvl="0" indent="-342900">
              <a:lnSpc>
                <a:spcPct val="115000"/>
              </a:lnSpc>
              <a:buFont typeface="Aptos" panose="020B0004020202020204" pitchFamily="34" charset="0"/>
              <a:buChar char="-"/>
            </a:pPr>
            <a:r>
              <a:rPr lang="en-US" sz="1800" kern="1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Despite rare biopsy-related tumor seeding risks, targeted transcutaneous biopsy remains safe.</a:t>
            </a:r>
            <a:endParaRPr lang="de-CH" sz="1800" kern="100" dirty="0">
              <a:solidFill>
                <a:schemeClr val="tx2"/>
              </a:solidFill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  <a:p>
            <a:pPr marL="342900" lvl="0" indent="-342900">
              <a:lnSpc>
                <a:spcPct val="115000"/>
              </a:lnSpc>
              <a:buFont typeface="Aptos" panose="020B0004020202020204" pitchFamily="34" charset="0"/>
              <a:buChar char="-"/>
            </a:pPr>
            <a:r>
              <a:rPr lang="en-US" sz="1800" kern="1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daptation of chemotherapy dosing to </a:t>
            </a:r>
            <a:r>
              <a:rPr lang="en-US" kern="100" dirty="0">
                <a:solidFill>
                  <a:schemeClr val="tx2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eGFR is essential to avoid overexposure and toxicity. </a:t>
            </a:r>
          </a:p>
          <a:p>
            <a:pPr marL="342900" lvl="0" indent="-342900">
              <a:lnSpc>
                <a:spcPct val="115000"/>
              </a:lnSpc>
              <a:buFont typeface="Aptos" panose="020B0004020202020204" pitchFamily="34" charset="0"/>
              <a:buChar char="-"/>
            </a:pPr>
            <a:r>
              <a:rPr lang="en-US" kern="100" dirty="0">
                <a:solidFill>
                  <a:schemeClr val="tx2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O</a:t>
            </a:r>
            <a:r>
              <a:rPr lang="en-US" sz="1800" kern="1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ptimize highly efficient hemodialysis sessions (HDF with high-flux dialyzers</a:t>
            </a:r>
            <a:r>
              <a:rPr lang="en-US" kern="100" dirty="0">
                <a:solidFill>
                  <a:schemeClr val="tx2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)</a:t>
            </a:r>
            <a:r>
              <a:rPr lang="en-US" sz="1800" kern="1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 permits tailoring the timing of chemotherapy exposure, avoiding chemotherapy accumulation, and </a:t>
            </a:r>
            <a:r>
              <a:rPr lang="en-US" kern="1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minimizing side effects. </a:t>
            </a:r>
            <a:endParaRPr lang="de-CH" kern="100" dirty="0">
              <a:solidFill>
                <a:schemeClr val="tx2"/>
              </a:solidFill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  <a:p>
            <a:pPr marL="342900" lvl="0" indent="-342900">
              <a:lnSpc>
                <a:spcPct val="115000"/>
              </a:lnSpc>
              <a:spcAft>
                <a:spcPts val="800"/>
              </a:spcAft>
              <a:buFont typeface="Aptos" panose="020B0004020202020204" pitchFamily="34" charset="0"/>
              <a:buChar char="-"/>
            </a:pPr>
            <a:r>
              <a:rPr lang="en-US" sz="1800" kern="100" dirty="0">
                <a:solidFill>
                  <a:schemeClr val="tx2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lthough large B-cell lymphoma responds well to chemotherapy, kidney outcomes depend on tumor infiltration, residual function, and nephrotoxic drug exposure. </a:t>
            </a:r>
            <a:endParaRPr lang="de-CH" sz="1800" kern="100" dirty="0">
              <a:solidFill>
                <a:schemeClr val="tx2"/>
              </a:solidFill>
              <a:effectLst/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ertacchi et al. 2025</a:t>
            </a:r>
            <a:endParaRPr lang="en-GB" sz="1400" b="1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9649" y="5804236"/>
            <a:ext cx="731108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anaging chemotherapy in kidney failure is challenging and requires a multidisciplinary team to adjust drug dosing and hemodialysis protocols, improving patient tolerance while maintaining treatment efficacy.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C5B12A2-243D-4F07-8B80-078DE329678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581" r="4462"/>
          <a:stretch/>
        </p:blipFill>
        <p:spPr>
          <a:xfrm>
            <a:off x="7348099" y="1758435"/>
            <a:ext cx="4787416" cy="36712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70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ssimiliano Bertacchi</dc:creator>
  <cp:lastModifiedBy>Bob Thompson</cp:lastModifiedBy>
  <cp:revision>3</cp:revision>
  <dcterms:created xsi:type="dcterms:W3CDTF">2025-05-16T17:15:01Z</dcterms:created>
  <dcterms:modified xsi:type="dcterms:W3CDTF">2025-05-16T18:44:18Z</dcterms:modified>
</cp:coreProperties>
</file>